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72.png" ContentType="image/png"/>
  <Override PartName="/ppt/media/image23.png" ContentType="image/png"/>
  <Override PartName="/ppt/media/image60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40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41A8F-0D4A-494A-AC21-7EC9AE9EC8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75C46-A89B-4133-B399-57C4D413B6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E3C2B-CF5B-4BAC-A57A-E919370366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5833B-92ED-4DD2-9395-D37BE21CC0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B5E41-B3C6-4AA3-AC8A-72132FA9BB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B6ACF-7F8A-4F6D-BDFC-2068E4246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C414B-F4DD-4CA7-A3C5-11D2E17E9B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DCAEF-8F4B-4CA0-9CDD-56974AF204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E5A44-C9E0-4B6D-BB05-7632AC60D3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B746E-47B3-4854-A30B-35678DB9F5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D5326-0F70-48AB-96B2-817A6C811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7FB86-359E-422D-B078-331F89E515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07FDA2-96DF-48EB-AEEC-22A3536E8EF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35.png"/><Relationship Id="rId3" Type="http://schemas.openxmlformats.org/officeDocument/2006/relationships/image" Target="../media/image36.pn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png"/><Relationship Id="rId3" Type="http://schemas.openxmlformats.org/officeDocument/2006/relationships/image" Target="../media/image60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png"/><Relationship Id="rId3" Type="http://schemas.openxmlformats.org/officeDocument/2006/relationships/image" Target="../media/image63.pn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image" Target="../media/image66.png"/><Relationship Id="rId4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image" Target="../media/image68.png"/><Relationship Id="rId3" Type="http://schemas.openxmlformats.org/officeDocument/2006/relationships/image" Target="../media/image69.pn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image" Target="../media/image71.png"/><Relationship Id="rId3" Type="http://schemas.openxmlformats.org/officeDocument/2006/relationships/image" Target="../media/image72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03-04-07T20:47:14Z</dcterms:modified>
  <cp:revision>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